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9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AIL A ROBERTSON" initials="GAR" lastIdx="11" clrIdx="0">
    <p:extLst>
      <p:ext uri="{19B8F6BF-5375-455C-9EA6-DF929625EA0E}">
        <p15:presenceInfo xmlns:p15="http://schemas.microsoft.com/office/powerpoint/2012/main" userId="97a3b06b-7fec-4ecd-9741-f2397d70eacd" providerId="Windows Live"/>
      </p:ext>
    </p:extLst>
  </p:cmAuthor>
  <p:cmAuthor id="2" name="Catherine" initials="C" lastIdx="1" clrIdx="1">
    <p:extLst>
      <p:ext uri="{19B8F6BF-5375-455C-9EA6-DF929625EA0E}">
        <p15:presenceInfo xmlns:p15="http://schemas.microsoft.com/office/powerpoint/2012/main" userId="Catherine" providerId="None"/>
      </p:ext>
    </p:extLst>
  </p:cmAuthor>
  <p:cmAuthor id="3" name="GAIL A ROBERTSON" initials="GAR [2]" lastIdx="10" clrIdx="2">
    <p:extLst>
      <p:ext uri="{19B8F6BF-5375-455C-9EA6-DF929625EA0E}">
        <p15:presenceInfo xmlns:p15="http://schemas.microsoft.com/office/powerpoint/2012/main" userId="S::garobert@wisc.edu::97a3b06b-7fec-4ecd-9741-f2397d70eac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DEE3"/>
    <a:srgbClr val="A0F2F4"/>
    <a:srgbClr val="A0F1F4"/>
    <a:srgbClr val="F17286"/>
    <a:srgbClr val="E0697A"/>
    <a:srgbClr val="2EDDE2"/>
    <a:srgbClr val="0080FF"/>
    <a:srgbClr val="000080"/>
    <a:srgbClr val="0087EA"/>
    <a:srgbClr val="6AE2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4" autoAdjust="0"/>
    <p:restoredTop sz="91091" autoAdjust="0"/>
  </p:normalViewPr>
  <p:slideViewPr>
    <p:cSldViewPr snapToGrid="0" snapToObjects="1">
      <p:cViewPr>
        <p:scale>
          <a:sx n="140" d="100"/>
          <a:sy n="140" d="100"/>
        </p:scale>
        <p:origin x="1904" y="14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4A77E5-9341-7446-87B9-D14147A0202E}" type="datetimeFigureOut">
              <a:rPr lang="fr-FR" smtClean="0"/>
              <a:t>20/11/2019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B84732-1DF6-5E40-99F8-E953FE5749E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8022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944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628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192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8792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4225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8515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3539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207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3659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171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026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BD31E-EC2D-534B-9860-5A5F763265D6}" type="datetimeFigureOut">
              <a:rPr lang="fr-FR" smtClean="0"/>
              <a:t>20/11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8393A-956C-D242-BDEC-E01C9F432F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0718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ZoneTexte 31"/>
          <p:cNvSpPr txBox="1"/>
          <p:nvPr/>
        </p:nvSpPr>
        <p:spPr>
          <a:xfrm>
            <a:off x="4858873" y="206935"/>
            <a:ext cx="28954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le 2</a:t>
            </a:r>
          </a:p>
        </p:txBody>
      </p:sp>
      <p:graphicFrame>
        <p:nvGraphicFramePr>
          <p:cNvPr id="3" name="Tableau 2">
            <a:extLst>
              <a:ext uri="{FF2B5EF4-FFF2-40B4-BE49-F238E27FC236}">
                <a16:creationId xmlns:a16="http://schemas.microsoft.com/office/drawing/2014/main" id="{5BB23B9B-DAAB-2B4D-8919-B90163C449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5903493"/>
              </p:ext>
            </p:extLst>
          </p:nvPr>
        </p:nvGraphicFramePr>
        <p:xfrm>
          <a:off x="473528" y="1176864"/>
          <a:ext cx="5894614" cy="23328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1143">
                  <a:extLst>
                    <a:ext uri="{9D8B030D-6E8A-4147-A177-3AD203B41FA5}">
                      <a16:colId xmlns:a16="http://schemas.microsoft.com/office/drawing/2014/main" val="4114415091"/>
                    </a:ext>
                  </a:extLst>
                </a:gridCol>
                <a:gridCol w="1647932">
                  <a:extLst>
                    <a:ext uri="{9D8B030D-6E8A-4147-A177-3AD203B41FA5}">
                      <a16:colId xmlns:a16="http://schemas.microsoft.com/office/drawing/2014/main" val="176073011"/>
                    </a:ext>
                  </a:extLst>
                </a:gridCol>
                <a:gridCol w="885788">
                  <a:extLst>
                    <a:ext uri="{9D8B030D-6E8A-4147-A177-3AD203B41FA5}">
                      <a16:colId xmlns:a16="http://schemas.microsoft.com/office/drawing/2014/main" val="3970855537"/>
                    </a:ext>
                  </a:extLst>
                </a:gridCol>
                <a:gridCol w="895187">
                  <a:extLst>
                    <a:ext uri="{9D8B030D-6E8A-4147-A177-3AD203B41FA5}">
                      <a16:colId xmlns:a16="http://schemas.microsoft.com/office/drawing/2014/main" val="3588322893"/>
                    </a:ext>
                  </a:extLst>
                </a:gridCol>
                <a:gridCol w="930431">
                  <a:extLst>
                    <a:ext uri="{9D8B030D-6E8A-4147-A177-3AD203B41FA5}">
                      <a16:colId xmlns:a16="http://schemas.microsoft.com/office/drawing/2014/main" val="1931386557"/>
                    </a:ext>
                  </a:extLst>
                </a:gridCol>
                <a:gridCol w="864133">
                  <a:extLst>
                    <a:ext uri="{9D8B030D-6E8A-4147-A177-3AD203B41FA5}">
                      <a16:colId xmlns:a16="http://schemas.microsoft.com/office/drawing/2014/main" val="2763969397"/>
                    </a:ext>
                  </a:extLst>
                </a:gridCol>
              </a:tblGrid>
              <a:tr h="329022">
                <a:tc>
                  <a:txBody>
                    <a:bodyPr/>
                    <a:lstStyle/>
                    <a:p>
                      <a:pPr algn="l" fontAlgn="b"/>
                      <a:endParaRPr lang="fr-FR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G1a/SCN5A </a:t>
                      </a:r>
                    </a:p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1 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G1a/RyR2 </a:t>
                      </a:r>
                    </a:p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6 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G1a/GAPDH </a:t>
                      </a:r>
                    </a:p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3 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N5A/GAPDH </a:t>
                      </a:r>
                    </a:p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8 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4087410"/>
                  </a:ext>
                </a:extLst>
              </a:tr>
              <a:tr h="20107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rson’s</a:t>
                      </a:r>
                      <a:endParaRPr lang="fr-FR" sz="800" b="1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ctr"/>
                      <a:r>
                        <a:rPr lang="fr-FR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est</a:t>
                      </a:r>
                      <a:endParaRPr lang="fr-FR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relation</a:t>
                      </a:r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efficient R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4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5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97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08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9024835"/>
                  </a:ext>
                </a:extLst>
              </a:tr>
              <a:tr h="20107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efficient of </a:t>
                      </a:r>
                      <a:r>
                        <a:rPr lang="fr-FR" sz="7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ermination</a:t>
                      </a:r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b="1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fr-FR" sz="700" b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fr-FR" sz="7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943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66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6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15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8194344"/>
                  </a:ext>
                </a:extLst>
              </a:tr>
              <a:tr h="20107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P value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01 (***)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58 (*)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3373 (ns)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6 (*)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707936"/>
                  </a:ext>
                </a:extLst>
              </a:tr>
              <a:tr h="20107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fr-FR" sz="7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ope</a:t>
                      </a:r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</a:t>
                      </a:r>
                      <a:r>
                        <a:rPr lang="fr-FR" sz="7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</a:t>
                      </a:r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ression</a:t>
                      </a:r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ine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4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3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6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51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004907"/>
                  </a:ext>
                </a:extLst>
              </a:tr>
              <a:tr h="397471">
                <a:tc vMerge="1">
                  <a:txBody>
                    <a:bodyPr/>
                    <a:lstStyle/>
                    <a:p>
                      <a:pPr algn="ctr" fontAlgn="ctr"/>
                      <a:endParaRPr lang="fr-FR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Significance </a:t>
                      </a:r>
                      <a:r>
                        <a:rPr lang="fr-FR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</a:t>
                      </a:r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nferroni</a:t>
                      </a:r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l" fontAlgn="ctr"/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correc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P&lt;0.038 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 P&lt;0.0076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* P&lt;0.0007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P&lt;0.024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 P&lt;0.0049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* P&lt;0.000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P&lt;0.023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 P&lt;0.0046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* P&lt;0.000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P&lt;0.025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 P&lt;0.005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* P&lt;0.00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7118724"/>
                  </a:ext>
                </a:extLst>
              </a:tr>
              <a:tr h="20107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arman's</a:t>
                      </a:r>
                      <a:r>
                        <a:rPr lang="fr-FR" sz="8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est</a:t>
                      </a:r>
                      <a:endParaRPr lang="fr-FR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fr-FR" sz="7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relation</a:t>
                      </a:r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efficient </a:t>
                      </a:r>
                      <a:r>
                        <a:rPr lang="fr-FR" sz="7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ρ</a:t>
                      </a:r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49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24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90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92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1192293"/>
                  </a:ext>
                </a:extLst>
              </a:tr>
              <a:tr h="20107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P value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***)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84 (ns)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991 (*)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315 (ns)</a:t>
                      </a:r>
                      <a:endParaRPr lang="fr-FR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4648621"/>
                  </a:ext>
                </a:extLst>
              </a:tr>
              <a:tr h="399957">
                <a:tc vMerge="1">
                  <a:txBody>
                    <a:bodyPr/>
                    <a:lstStyle/>
                    <a:p>
                      <a:pPr algn="ctr" fontAlgn="ctr"/>
                      <a:endParaRPr lang="fr-FR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Significance </a:t>
                      </a:r>
                      <a:r>
                        <a:rPr lang="fr-FR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ter</a:t>
                      </a:r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nferroni</a:t>
                      </a:r>
                      <a:endParaRPr lang="fr-FR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 fontAlgn="ctr"/>
                      <a:r>
                        <a:rPr lang="fr-FR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correc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P&lt;0.019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 P&lt;0.0039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* P&lt;0.0003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P&lt;0.0055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 P&lt;0.0011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 P&lt;0.000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P&lt;0.013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 P&lt;0.0027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 P&lt;0.000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 P&lt;0.0061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 P&lt;0.0012</a:t>
                      </a:r>
                    </a:p>
                    <a:p>
                      <a:pPr marL="0" indent="0" algn="ctr" fontAlgn="ctr">
                        <a:buFontTx/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** P&lt;0.000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02471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11345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048</TotalTime>
  <Words>221</Words>
  <Application>Microsoft Macintosh PowerPoint</Application>
  <PresentationFormat>On-screen Show (4:3)</PresentationFormat>
  <Paragraphs>7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atherine</dc:creator>
  <cp:keywords/>
  <dc:description/>
  <cp:lastModifiedBy>Microsoft Office User</cp:lastModifiedBy>
  <cp:revision>411</cp:revision>
  <cp:lastPrinted>2019-10-01T00:24:33Z</cp:lastPrinted>
  <dcterms:created xsi:type="dcterms:W3CDTF">2017-07-07T12:54:23Z</dcterms:created>
  <dcterms:modified xsi:type="dcterms:W3CDTF">2019-11-20T15:30:37Z</dcterms:modified>
  <cp:category/>
</cp:coreProperties>
</file>